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5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311" r:id="rId2"/>
    <p:sldId id="319" r:id="rId3"/>
    <p:sldId id="312" r:id="rId4"/>
    <p:sldId id="317" r:id="rId5"/>
    <p:sldId id="318" r:id="rId6"/>
    <p:sldId id="320" r:id="rId7"/>
  </p:sldIdLst>
  <p:sldSz cx="6858000" cy="9144000" type="letter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16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81B"/>
    <a:srgbClr val="F7681B"/>
    <a:srgbClr val="FFB820"/>
    <a:srgbClr val="FFC70B"/>
    <a:srgbClr val="FFAC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60" autoAdjust="0"/>
    <p:restoredTop sz="93542" autoAdjust="0"/>
  </p:normalViewPr>
  <p:slideViewPr>
    <p:cSldViewPr>
      <p:cViewPr>
        <p:scale>
          <a:sx n="93" d="100"/>
          <a:sy n="93" d="100"/>
        </p:scale>
        <p:origin x="480" y="-1692"/>
      </p:cViewPr>
      <p:guideLst>
        <p:guide orient="horz" pos="816"/>
        <p:guide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-Corey%20lab%20research\1-My%20papers\6-%20RNA%20Article%202019\05212019-Revise%20and%20Resubmit\additional%20control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377814498851"/>
          <c:y val="4.18025583846608E-2"/>
          <c:w val="0.87200383137948501"/>
          <c:h val="0.86759399800682502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F$37:$I$37</c:f>
                <c:numCache>
                  <c:formatCode>General</c:formatCode>
                  <c:ptCount val="4"/>
                  <c:pt idx="0">
                    <c:v>2.7977884848568099E-2</c:v>
                  </c:pt>
                  <c:pt idx="1">
                    <c:v>5.5662079224854302E-3</c:v>
                  </c:pt>
                  <c:pt idx="2">
                    <c:v>0.20613603317791801</c:v>
                  </c:pt>
                  <c:pt idx="3">
                    <c:v>4.1323360026817597E-3</c:v>
                  </c:pt>
                </c:numCache>
              </c:numRef>
            </c:plus>
            <c:minus>
              <c:numRef>
                <c:f>Sheet1!$F$37:$I$37</c:f>
                <c:numCache>
                  <c:formatCode>General</c:formatCode>
                  <c:ptCount val="4"/>
                  <c:pt idx="0">
                    <c:v>2.7977884848568099E-2</c:v>
                  </c:pt>
                  <c:pt idx="1">
                    <c:v>5.5662079224854302E-3</c:v>
                  </c:pt>
                  <c:pt idx="2">
                    <c:v>0.20613603317791801</c:v>
                  </c:pt>
                  <c:pt idx="3">
                    <c:v>4.1323360026817597E-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F$31:$I$31</c:f>
              <c:strCache>
                <c:ptCount val="4"/>
                <c:pt idx="0">
                  <c:v>ctrl-gap</c:v>
                </c:pt>
                <c:pt idx="1">
                  <c:v>anti-MALAT1</c:v>
                </c:pt>
                <c:pt idx="2">
                  <c:v>ctrl-gap</c:v>
                </c:pt>
                <c:pt idx="3">
                  <c:v>anti-MALAT1</c:v>
                </c:pt>
              </c:strCache>
            </c:strRef>
          </c:cat>
          <c:val>
            <c:numRef>
              <c:f>Sheet1!$F$36:$I$36</c:f>
              <c:numCache>
                <c:formatCode>General</c:formatCode>
                <c:ptCount val="4"/>
                <c:pt idx="0">
                  <c:v>1</c:v>
                </c:pt>
                <c:pt idx="1">
                  <c:v>3.5014862664233898E-2</c:v>
                </c:pt>
                <c:pt idx="2">
                  <c:v>1.056606895301593</c:v>
                </c:pt>
                <c:pt idx="3">
                  <c:v>0.82859261098200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9B-4A02-AA06-F198EAEEA89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-477447872"/>
        <c:axId val="-423711616"/>
      </c:barChart>
      <c:catAx>
        <c:axId val="-47744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-423711616"/>
        <c:crosses val="autoZero"/>
        <c:auto val="1"/>
        <c:lblAlgn val="ctr"/>
        <c:lblOffset val="100"/>
        <c:noMultiLvlLbl val="0"/>
      </c:catAx>
      <c:valAx>
        <c:axId val="-423711616"/>
        <c:scaling>
          <c:orientation val="minMax"/>
          <c:max val="1.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-477447872"/>
        <c:crosses val="autoZero"/>
        <c:crossBetween val="between"/>
        <c:majorUnit val="0.2"/>
      </c:valAx>
      <c:spPr>
        <a:noFill/>
        <a:ln>
          <a:noFill/>
        </a:ln>
        <a:effectLst>
          <a:softEdge rad="190500"/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312910104987"/>
          <c:y val="4.18025583846608E-2"/>
          <c:w val="0.84306854221347305"/>
          <c:h val="0.84485515699426506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OMBINED!$F$9:$L$9</c:f>
                <c:numCache>
                  <c:formatCode>General</c:formatCode>
                  <c:ptCount val="7"/>
                  <c:pt idx="0">
                    <c:v>0.18479770769798337</c:v>
                  </c:pt>
                  <c:pt idx="1">
                    <c:v>0.12969538943354048</c:v>
                  </c:pt>
                  <c:pt idx="2">
                    <c:v>7.1635923084803932E-2</c:v>
                  </c:pt>
                  <c:pt idx="3">
                    <c:v>6.2246874953636809E-2</c:v>
                  </c:pt>
                  <c:pt idx="4">
                    <c:v>5.0953681586442243E-2</c:v>
                  </c:pt>
                  <c:pt idx="5">
                    <c:v>2.0589620084898563E-2</c:v>
                  </c:pt>
                  <c:pt idx="6">
                    <c:v>1.444007597471011E-2</c:v>
                  </c:pt>
                </c:numCache>
              </c:numRef>
            </c:plus>
            <c:minus>
              <c:numRef>
                <c:f>COMBINED!$F$9:$L$9</c:f>
                <c:numCache>
                  <c:formatCode>General</c:formatCode>
                  <c:ptCount val="7"/>
                  <c:pt idx="0">
                    <c:v>0.18479770769798337</c:v>
                  </c:pt>
                  <c:pt idx="1">
                    <c:v>0.12969538943354048</c:v>
                  </c:pt>
                  <c:pt idx="2">
                    <c:v>7.1635923084803932E-2</c:v>
                  </c:pt>
                  <c:pt idx="3">
                    <c:v>6.2246874953636809E-2</c:v>
                  </c:pt>
                  <c:pt idx="4">
                    <c:v>5.0953681586442243E-2</c:v>
                  </c:pt>
                  <c:pt idx="5">
                    <c:v>2.0589620084898563E-2</c:v>
                  </c:pt>
                  <c:pt idx="6">
                    <c:v>1.444007597471011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COMBINED!$F$1:$L$1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</c:numCache>
            </c:numRef>
          </c:cat>
          <c:val>
            <c:numRef>
              <c:f>COMBINED!$F$8:$L$8</c:f>
              <c:numCache>
                <c:formatCode>General</c:formatCode>
                <c:ptCount val="7"/>
                <c:pt idx="0">
                  <c:v>1</c:v>
                </c:pt>
                <c:pt idx="1">
                  <c:v>0.63085323390192138</c:v>
                </c:pt>
                <c:pt idx="2">
                  <c:v>0.48594304940078326</c:v>
                </c:pt>
                <c:pt idx="3">
                  <c:v>0.34638225535508288</c:v>
                </c:pt>
                <c:pt idx="4">
                  <c:v>0.28962871697581666</c:v>
                </c:pt>
                <c:pt idx="5">
                  <c:v>8.8011074335074366E-2</c:v>
                </c:pt>
                <c:pt idx="6">
                  <c:v>5.196716521303466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E5-48D5-8A5D-737B3FC270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926131712"/>
        <c:axId val="-926131184"/>
      </c:barChart>
      <c:catAx>
        <c:axId val="-92613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-926131184"/>
        <c:crosses val="autoZero"/>
        <c:auto val="1"/>
        <c:lblAlgn val="ctr"/>
        <c:lblOffset val="100"/>
        <c:noMultiLvlLbl val="0"/>
      </c:catAx>
      <c:valAx>
        <c:axId val="-926131184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-926131712"/>
        <c:crosses val="autoZero"/>
        <c:crossBetween val="between"/>
        <c:majorUnit val="0.2"/>
      </c:valAx>
      <c:spPr>
        <a:noFill/>
        <a:ln>
          <a:noFill/>
        </a:ln>
        <a:effectLst>
          <a:softEdge rad="190500"/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41939158646801"/>
          <c:y val="4.18025583846608E-2"/>
          <c:w val="0.84596206073199198"/>
          <c:h val="0.85421798236758895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480 used'!$F$38:$M$3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7871559565965399E-2</c:v>
                  </c:pt>
                  <c:pt idx="2">
                    <c:v>3.8935819251141673E-2</c:v>
                  </c:pt>
                  <c:pt idx="3">
                    <c:v>7.4805235672047776E-2</c:v>
                  </c:pt>
                  <c:pt idx="4">
                    <c:v>1.7190828018104967E-2</c:v>
                  </c:pt>
                  <c:pt idx="5">
                    <c:v>5.1306820109904084E-3</c:v>
                  </c:pt>
                  <c:pt idx="6">
                    <c:v>1.0555905456789061E-2</c:v>
                  </c:pt>
                  <c:pt idx="7">
                    <c:v>4.7084006103406614E-3</c:v>
                  </c:pt>
                </c:numCache>
              </c:numRef>
            </c:plus>
            <c:minus>
              <c:numRef>
                <c:f>'480 used'!$F$38:$M$3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7871559565965399E-2</c:v>
                  </c:pt>
                  <c:pt idx="2">
                    <c:v>3.8935819251141673E-2</c:v>
                  </c:pt>
                  <c:pt idx="3">
                    <c:v>7.4805235672047776E-2</c:v>
                  </c:pt>
                  <c:pt idx="4">
                    <c:v>1.7190828018104967E-2</c:v>
                  </c:pt>
                  <c:pt idx="5">
                    <c:v>5.1306820109904084E-3</c:v>
                  </c:pt>
                  <c:pt idx="6">
                    <c:v>1.0555905456789061E-2</c:v>
                  </c:pt>
                  <c:pt idx="7">
                    <c:v>4.7084006103406614E-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480 used'!$F$31:$M$31</c:f>
              <c:numCache>
                <c:formatCode>General</c:formatCode>
                <c:ptCount val="8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8</c:v>
                </c:pt>
                <c:pt idx="4">
                  <c:v>1.6</c:v>
                </c:pt>
                <c:pt idx="5">
                  <c:v>3</c:v>
                </c:pt>
                <c:pt idx="6">
                  <c:v>6</c:v>
                </c:pt>
                <c:pt idx="7">
                  <c:v>12</c:v>
                </c:pt>
              </c:numCache>
            </c:numRef>
          </c:cat>
          <c:val>
            <c:numRef>
              <c:f>'480 used'!$F$37:$M$37</c:f>
              <c:numCache>
                <c:formatCode>General</c:formatCode>
                <c:ptCount val="8"/>
                <c:pt idx="0">
                  <c:v>1</c:v>
                </c:pt>
                <c:pt idx="1">
                  <c:v>0.40095727502825329</c:v>
                </c:pt>
                <c:pt idx="2">
                  <c:v>0.38214989042268183</c:v>
                </c:pt>
                <c:pt idx="3">
                  <c:v>0.17139237967464288</c:v>
                </c:pt>
                <c:pt idx="4">
                  <c:v>0.11932126378946076</c:v>
                </c:pt>
                <c:pt idx="5">
                  <c:v>4.9656352925244979E-2</c:v>
                </c:pt>
                <c:pt idx="6">
                  <c:v>3.0523615267118484E-2</c:v>
                </c:pt>
                <c:pt idx="7">
                  <c:v>2.704579168990826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966-4F59-8029-CDDDF7F285DD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-421287696"/>
        <c:axId val="118531024"/>
      </c:barChart>
      <c:catAx>
        <c:axId val="-421287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118531024"/>
        <c:crosses val="autoZero"/>
        <c:auto val="1"/>
        <c:lblAlgn val="ctr"/>
        <c:lblOffset val="100"/>
        <c:noMultiLvlLbl val="0"/>
      </c:catAx>
      <c:valAx>
        <c:axId val="118531024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-421287696"/>
        <c:crosses val="autoZero"/>
        <c:crossBetween val="between"/>
        <c:majorUnit val="0.2"/>
      </c:valAx>
      <c:spPr>
        <a:noFill/>
        <a:ln>
          <a:noFill/>
        </a:ln>
        <a:effectLst>
          <a:softEdge rad="190500"/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37781449885135"/>
          <c:y val="4.1802558384660862E-2"/>
          <c:w val="0.87200383137948467"/>
          <c:h val="0.85379063194023819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39:$G$39</c:f>
                <c:numCache>
                  <c:formatCode>General</c:formatCode>
                  <c:ptCount val="2"/>
                  <c:pt idx="0">
                    <c:v>4.1327835570781998E-2</c:v>
                  </c:pt>
                  <c:pt idx="1">
                    <c:v>7.7923250132560073E-2</c:v>
                  </c:pt>
                </c:numCache>
              </c:numRef>
            </c:plus>
            <c:minus>
              <c:numRef>
                <c:f>Sheet2!$F$39:$G$39</c:f>
                <c:numCache>
                  <c:formatCode>General</c:formatCode>
                  <c:ptCount val="2"/>
                  <c:pt idx="0">
                    <c:v>4.1327835570781998E-2</c:v>
                  </c:pt>
                  <c:pt idx="1">
                    <c:v>7.7923250132560073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31:$G$31</c:f>
              <c:strCache>
                <c:ptCount val="2"/>
                <c:pt idx="0">
                  <c:v>EP(-)</c:v>
                </c:pt>
                <c:pt idx="1">
                  <c:v>0-EP</c:v>
                </c:pt>
              </c:strCache>
            </c:strRef>
          </c:cat>
          <c:val>
            <c:numRef>
              <c:f>Sheet2!$F$38:$G$38</c:f>
              <c:numCache>
                <c:formatCode>General</c:formatCode>
                <c:ptCount val="2"/>
                <c:pt idx="0">
                  <c:v>1</c:v>
                </c:pt>
                <c:pt idx="1">
                  <c:v>0.89936591712225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41-4416-B81C-5F54B39778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22977224"/>
        <c:axId val="422977552"/>
      </c:barChart>
      <c:catAx>
        <c:axId val="422977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422977552"/>
        <c:crosses val="autoZero"/>
        <c:auto val="1"/>
        <c:lblAlgn val="ctr"/>
        <c:lblOffset val="100"/>
        <c:noMultiLvlLbl val="0"/>
      </c:catAx>
      <c:valAx>
        <c:axId val="422977552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422977224"/>
        <c:crosses val="autoZero"/>
        <c:crossBetween val="between"/>
        <c:majorUnit val="0.2"/>
      </c:valAx>
      <c:spPr>
        <a:noFill/>
        <a:ln>
          <a:noFill/>
        </a:ln>
        <a:effectLst>
          <a:softEdge rad="190500"/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042777" cy="467204"/>
          </a:xfrm>
          <a:prstGeom prst="rect">
            <a:avLst/>
          </a:prstGeom>
        </p:spPr>
        <p:txBody>
          <a:bodyPr vert="horz" lIns="92272" tIns="46136" rIns="92272" bIns="4613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5529" y="2"/>
            <a:ext cx="3042776" cy="467204"/>
          </a:xfrm>
          <a:prstGeom prst="rect">
            <a:avLst/>
          </a:prstGeom>
        </p:spPr>
        <p:txBody>
          <a:bodyPr vert="horz" lIns="92272" tIns="46136" rIns="92272" bIns="46136" rtlCol="0"/>
          <a:lstStyle>
            <a:lvl1pPr algn="r">
              <a:defRPr sz="1200"/>
            </a:lvl1pPr>
          </a:lstStyle>
          <a:p>
            <a:fld id="{F4819A29-02C9-4308-A888-E32D786D6408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8838723"/>
            <a:ext cx="3042777" cy="467204"/>
          </a:xfrm>
          <a:prstGeom prst="rect">
            <a:avLst/>
          </a:prstGeom>
        </p:spPr>
        <p:txBody>
          <a:bodyPr vert="horz" lIns="92272" tIns="46136" rIns="92272" bIns="4613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5529" y="8838723"/>
            <a:ext cx="3042776" cy="467204"/>
          </a:xfrm>
          <a:prstGeom prst="rect">
            <a:avLst/>
          </a:prstGeom>
        </p:spPr>
        <p:txBody>
          <a:bodyPr vert="horz" lIns="92272" tIns="46136" rIns="92272" bIns="46136" rtlCol="0" anchor="b"/>
          <a:lstStyle>
            <a:lvl1pPr algn="r">
              <a:defRPr sz="1200"/>
            </a:lvl1pPr>
          </a:lstStyle>
          <a:p>
            <a:fld id="{A06EC301-5E1A-4283-94EC-352FA94BE5F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3768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4" y="0"/>
            <a:ext cx="3041968" cy="465296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04660C18-325F-40EF-9D9E-990F994709F3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1" rIns="93279" bIns="4664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79" tIns="46641" rIns="93279" bIns="4664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4" y="8839014"/>
            <a:ext cx="3041968" cy="465296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D30CAAD6-E06D-4CE8-BA9A-0D2D135AEE5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35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0CAAD6-E06D-4CE8-BA9A-0D2D135AEE5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6571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0CAAD6-E06D-4CE8-BA9A-0D2D135AEE5E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2643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0CAAD6-E06D-4CE8-BA9A-0D2D135AEE5E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0510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0CAAD6-E06D-4CE8-BA9A-0D2D135AEE5E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9054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0CAAD6-E06D-4CE8-BA9A-0D2D135AEE5E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1888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1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1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76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1913475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6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7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3F460-D55B-4422-B437-B8F448C258B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C222-4CE2-4685-B169-5604FC634EE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2.png"/><Relationship Id="rId3" Type="http://schemas.openxmlformats.org/officeDocument/2006/relationships/image" Target="../media/image6.png"/><Relationship Id="rId7" Type="http://schemas.openxmlformats.org/officeDocument/2006/relationships/image" Target="../media/image9.png"/><Relationship Id="rId12" Type="http://schemas.microsoft.com/office/2007/relationships/hdphoto" Target="../media/hdphoto5.wdp"/><Relationship Id="rId2" Type="http://schemas.openxmlformats.org/officeDocument/2006/relationships/notesSlide" Target="../notesSlides/notesSlide5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1.png"/><Relationship Id="rId5" Type="http://schemas.openxmlformats.org/officeDocument/2006/relationships/image" Target="../media/image7.png"/><Relationship Id="rId15" Type="http://schemas.openxmlformats.org/officeDocument/2006/relationships/image" Target="../media/image13.png"/><Relationship Id="rId10" Type="http://schemas.microsoft.com/office/2007/relationships/hdphoto" Target="../media/hdphoto4.wdp"/><Relationship Id="rId4" Type="http://schemas.microsoft.com/office/2007/relationships/hdphoto" Target="../media/hdphoto2.wdp"/><Relationship Id="rId9" Type="http://schemas.openxmlformats.org/officeDocument/2006/relationships/image" Target="../media/image10.png"/><Relationship Id="rId14" Type="http://schemas.microsoft.com/office/2007/relationships/hdphoto" Target="../media/hdphoto6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09600" y="6484203"/>
            <a:ext cx="5486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.</a:t>
            </a:r>
            <a:r>
              <a:rPr lang="en-US" altLang="zh-CN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Characterization of iPSCs and NPCs used in this study. Karyotype analysis of F4259 and C7522 iPSC. Morphology of NPCs differentiated from patient and control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iPSCs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at the passage used for oligonucleotide transfection. P designates passage number. </a:t>
            </a:r>
            <a:endParaRPr lang="en-US" sz="1200" dirty="0"/>
          </a:p>
        </p:txBody>
      </p:sp>
      <p:grpSp>
        <p:nvGrpSpPr>
          <p:cNvPr id="12" name="Group 11"/>
          <p:cNvGrpSpPr>
            <a:grpSpLocks noChangeAspect="1"/>
          </p:cNvGrpSpPr>
          <p:nvPr/>
        </p:nvGrpSpPr>
        <p:grpSpPr>
          <a:xfrm>
            <a:off x="316358" y="1548032"/>
            <a:ext cx="6072885" cy="4791080"/>
            <a:chOff x="876927" y="800782"/>
            <a:chExt cx="7591105" cy="5988849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76927" y="1176975"/>
              <a:ext cx="3437573" cy="24688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1624479" y="800782"/>
              <a:ext cx="6338273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  F4259 iPSC p17                                         C7522 iPSC p15</a:t>
              </a: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44747" y="1188506"/>
              <a:ext cx="3423285" cy="24288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TextBox 15"/>
            <p:cNvSpPr txBox="1"/>
            <p:nvPr/>
          </p:nvSpPr>
          <p:spPr>
            <a:xfrm>
              <a:off x="5606405" y="3757963"/>
              <a:ext cx="2495073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 NPC p4 (day 5)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433979" y="3740768"/>
              <a:ext cx="2469026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F4259 NPC p4 (day 5)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06" t="30720" r="41102" b="35956"/>
            <a:stretch/>
          </p:blipFill>
          <p:spPr>
            <a:xfrm>
              <a:off x="1010574" y="4155183"/>
              <a:ext cx="3031958" cy="262288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36" t="33185" r="47732" b="33184"/>
            <a:stretch/>
          </p:blipFill>
          <p:spPr>
            <a:xfrm>
              <a:off x="5264474" y="4142684"/>
              <a:ext cx="2983832" cy="2646947"/>
            </a:xfrm>
            <a:prstGeom prst="rect">
              <a:avLst/>
            </a:prstGeom>
          </p:spPr>
        </p:pic>
        <p:cxnSp>
          <p:nvCxnSpPr>
            <p:cNvPr id="20" name="Straight Connector 19"/>
            <p:cNvCxnSpPr/>
            <p:nvPr/>
          </p:nvCxnSpPr>
          <p:spPr>
            <a:xfrm>
              <a:off x="3719979" y="6585137"/>
              <a:ext cx="29014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3554965" y="6551366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0 </a:t>
              </a:r>
              <a:r>
                <a:rPr lang="en-US" sz="800" dirty="0">
                  <a:latin typeface="Symbol" panose="05050102010706020507" pitchFamily="18" charset="2"/>
                </a:rPr>
                <a:t>m</a:t>
              </a:r>
              <a:r>
                <a:rPr lang="en-US" sz="800" dirty="0"/>
                <a:t>m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7912898" y="6603031"/>
              <a:ext cx="29014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7745965" y="655658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0 </a:t>
              </a:r>
              <a:r>
                <a:rPr lang="en-US" sz="800" dirty="0">
                  <a:latin typeface="Symbol" panose="05050102010706020507" pitchFamily="18" charset="2"/>
                </a:rPr>
                <a:t>m</a:t>
              </a:r>
              <a:r>
                <a:rPr lang="en-US" sz="800" dirty="0"/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65260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68352" y="5512004"/>
            <a:ext cx="5486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2.</a:t>
            </a:r>
            <a:r>
              <a:rPr lang="en-US" altLang="zh-CN" sz="1200" b="1" dirty="0">
                <a:latin typeface="Helvetica"/>
                <a:cs typeface="Helvetica"/>
              </a:rPr>
              <a:t> </a:t>
            </a:r>
            <a:r>
              <a:rPr lang="en-US" altLang="zh-CN" sz="1200" i="1" dirty="0">
                <a:latin typeface="Helvetica"/>
                <a:cs typeface="Helvetica"/>
              </a:rPr>
              <a:t>MALAT-1</a:t>
            </a:r>
            <a:r>
              <a:rPr lang="en-US" altLang="zh-CN" sz="1200" dirty="0">
                <a:latin typeface="Helvetica"/>
                <a:cs typeface="Helvetica"/>
              </a:rPr>
              <a:t> RNA knock down efficiency between electroporation and </a:t>
            </a:r>
            <a:r>
              <a:rPr lang="en-US" altLang="zh-CN" sz="1200" dirty="0" err="1">
                <a:latin typeface="Helvetica"/>
                <a:cs typeface="Helvetica"/>
              </a:rPr>
              <a:t>gymnotic</a:t>
            </a:r>
            <a:r>
              <a:rPr lang="en-US" altLang="zh-CN" sz="1200" dirty="0">
                <a:latin typeface="Helvetica"/>
                <a:cs typeface="Helvetica"/>
              </a:rPr>
              <a:t> free uptake at 20 µM post 24 hours transfection 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in </a:t>
            </a:r>
            <a:r>
              <a:rPr lang="en-US" altLang="zh-CN" sz="1200" dirty="0">
                <a:solidFill>
                  <a:prstClr val="black"/>
                </a:solidFill>
                <a:latin typeface="Helvetica"/>
                <a:cs typeface="Helvetica"/>
              </a:rPr>
              <a:t>FRDA patient derived neuronal progenitor cells F4259 (n=2)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ll data are presented as ±STDEV. *P &lt; 0.05, **P &lt; 0.01, ***P &lt; 0.001, </a:t>
            </a: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relative to each </a:t>
            </a:r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trl-gap</a:t>
            </a: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 treatment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by Student t-test. </a:t>
            </a:r>
            <a:endParaRPr lang="en-US" sz="12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356087" y="2147577"/>
            <a:ext cx="5836765" cy="3364427"/>
            <a:chOff x="259235" y="1828800"/>
            <a:chExt cx="5836765" cy="3364427"/>
          </a:xfrm>
        </p:grpSpPr>
        <p:grpSp>
          <p:nvGrpSpPr>
            <p:cNvPr id="2" name="Group 1"/>
            <p:cNvGrpSpPr/>
            <p:nvPr/>
          </p:nvGrpSpPr>
          <p:grpSpPr>
            <a:xfrm>
              <a:off x="609600" y="1828800"/>
              <a:ext cx="5486400" cy="3364427"/>
              <a:chOff x="609600" y="1828800"/>
              <a:chExt cx="5486400" cy="3364427"/>
            </a:xfrm>
          </p:grpSpPr>
          <p:grpSp>
            <p:nvGrpSpPr>
              <p:cNvPr id="4" name="Group 3"/>
              <p:cNvGrpSpPr>
                <a:grpSpLocks noChangeAspect="1"/>
              </p:cNvGrpSpPr>
              <p:nvPr/>
            </p:nvGrpSpPr>
            <p:grpSpPr>
              <a:xfrm>
                <a:off x="609600" y="1828800"/>
                <a:ext cx="5486400" cy="3364427"/>
                <a:chOff x="1548920" y="853585"/>
                <a:chExt cx="7232904" cy="3810001"/>
              </a:xfrm>
            </p:grpSpPr>
            <p:graphicFrame>
              <p:nvGraphicFramePr>
                <p:cNvPr id="5" name="Chart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44499823"/>
                    </p:ext>
                  </p:extLst>
                </p:nvPr>
              </p:nvGraphicFramePr>
              <p:xfrm>
                <a:off x="1548920" y="853585"/>
                <a:ext cx="7232904" cy="38100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pSp>
              <p:nvGrpSpPr>
                <p:cNvPr id="6" name="Group 5"/>
                <p:cNvGrpSpPr/>
                <p:nvPr/>
              </p:nvGrpSpPr>
              <p:grpSpPr>
                <a:xfrm>
                  <a:off x="2695228" y="1444905"/>
                  <a:ext cx="2286000" cy="305815"/>
                  <a:chOff x="2695228" y="1444905"/>
                  <a:chExt cx="2286000" cy="305815"/>
                </a:xfrm>
              </p:grpSpPr>
              <p:cxnSp>
                <p:nvCxnSpPr>
                  <p:cNvPr id="10" name="Straight Connector 9"/>
                  <p:cNvCxnSpPr/>
                  <p:nvPr/>
                </p:nvCxnSpPr>
                <p:spPr>
                  <a:xfrm>
                    <a:off x="2695228" y="1750720"/>
                    <a:ext cx="228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" name="Rectangle 10"/>
                  <p:cNvSpPr/>
                  <p:nvPr/>
                </p:nvSpPr>
                <p:spPr>
                  <a:xfrm>
                    <a:off x="3020172" y="1444905"/>
                    <a:ext cx="1636111" cy="27883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EP, Optimization 4</a:t>
                    </a:r>
                  </a:p>
                </p:txBody>
              </p:sp>
            </p:grpSp>
            <p:grpSp>
              <p:nvGrpSpPr>
                <p:cNvPr id="7" name="Group 6"/>
                <p:cNvGrpSpPr/>
                <p:nvPr/>
              </p:nvGrpSpPr>
              <p:grpSpPr>
                <a:xfrm>
                  <a:off x="6079604" y="941701"/>
                  <a:ext cx="2286000" cy="297192"/>
                  <a:chOff x="2695228" y="1422691"/>
                  <a:chExt cx="2286000" cy="297192"/>
                </a:xfrm>
              </p:grpSpPr>
              <p:cxnSp>
                <p:nvCxnSpPr>
                  <p:cNvPr id="8" name="Straight Connector 7"/>
                  <p:cNvCxnSpPr/>
                  <p:nvPr/>
                </p:nvCxnSpPr>
                <p:spPr>
                  <a:xfrm>
                    <a:off x="2695228" y="1719883"/>
                    <a:ext cx="228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" name="Rectangle 8"/>
                  <p:cNvSpPr/>
                  <p:nvPr/>
                </p:nvSpPr>
                <p:spPr>
                  <a:xfrm>
                    <a:off x="2917678" y="1422691"/>
                    <a:ext cx="1841100" cy="27883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Gymnotic free uptake</a:t>
                    </a:r>
                  </a:p>
                </p:txBody>
              </p:sp>
            </p:grpSp>
          </p:grpSp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667000" y="4453657"/>
                <a:ext cx="560881" cy="541009"/>
              </a:xfrm>
              <a:prstGeom prst="rect">
                <a:avLst/>
              </a:prstGeom>
            </p:spPr>
          </p:pic>
        </p:grpSp>
        <p:sp>
          <p:nvSpPr>
            <p:cNvPr id="13" name="Rectangle 12"/>
            <p:cNvSpPr/>
            <p:nvPr/>
          </p:nvSpPr>
          <p:spPr>
            <a:xfrm rot="5400000">
              <a:off x="248334" y="2968763"/>
              <a:ext cx="646331" cy="624530"/>
            </a:xfrm>
            <a:prstGeom prst="rect">
              <a:avLst/>
            </a:prstGeom>
          </p:spPr>
          <p:txBody>
            <a:bodyPr vert="vert270" wrap="none" anchor="t" anchorCtr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Relative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MALAT1 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RN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92309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838199" y="4816405"/>
            <a:ext cx="54102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3.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Dose dependent knock-down of </a:t>
            </a:r>
            <a:r>
              <a:rPr lang="en-US" sz="1200" i="1" dirty="0">
                <a:solidFill>
                  <a:prstClr val="black"/>
                </a:solidFill>
                <a:latin typeface="Helvetica"/>
                <a:cs typeface="Helvetica"/>
              </a:rPr>
              <a:t>MALAT-1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 RNA by </a:t>
            </a:r>
            <a:r>
              <a:rPr lang="en-US" sz="1200" b="1" dirty="0">
                <a:solidFill>
                  <a:prstClr val="black"/>
                </a:solidFill>
                <a:latin typeface="Helvetica"/>
                <a:cs typeface="Helvetica"/>
              </a:rPr>
              <a:t>anti-MALAT1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 using Optimization 4 in </a:t>
            </a:r>
            <a:r>
              <a:rPr lang="en-US" altLang="zh-CN" sz="1200" dirty="0">
                <a:solidFill>
                  <a:prstClr val="black"/>
                </a:solidFill>
                <a:latin typeface="Helvetica"/>
                <a:cs typeface="Helvetica"/>
              </a:rPr>
              <a:t>FRDA patient derived neuronal progenitor cells F4259 post 72h transfection (n=4)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ll data are presented as ±STDEV. </a:t>
            </a:r>
            <a:endParaRPr lang="en-US" sz="1200" dirty="0"/>
          </a:p>
        </p:txBody>
      </p:sp>
      <p:grpSp>
        <p:nvGrpSpPr>
          <p:cNvPr id="2" name="Group 1"/>
          <p:cNvGrpSpPr/>
          <p:nvPr/>
        </p:nvGrpSpPr>
        <p:grpSpPr>
          <a:xfrm>
            <a:off x="1008783" y="2438400"/>
            <a:ext cx="4675737" cy="2377440"/>
            <a:chOff x="1008783" y="2438400"/>
            <a:chExt cx="4675737" cy="2377440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07199721"/>
                </p:ext>
              </p:extLst>
            </p:nvPr>
          </p:nvGraphicFramePr>
          <p:xfrm>
            <a:off x="1295400" y="2438400"/>
            <a:ext cx="438912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4" name="Rectangle 13"/>
            <p:cNvSpPr/>
            <p:nvPr/>
          </p:nvSpPr>
          <p:spPr>
            <a:xfrm>
              <a:off x="2951584" y="2830292"/>
              <a:ext cx="1854995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IC</a:t>
              </a:r>
              <a:r>
                <a:rPr lang="en-US" sz="110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= 0.19 ± 0.05 µM</a:t>
              </a:r>
            </a:p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MALAT1 </a:t>
              </a:r>
              <a:r>
                <a:rPr lang="en-US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apmer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(µM)</a:t>
              </a:r>
            </a:p>
          </p:txBody>
        </p:sp>
        <p:sp>
          <p:nvSpPr>
            <p:cNvPr id="5" name="Rectangle 4"/>
            <p:cNvSpPr/>
            <p:nvPr/>
          </p:nvSpPr>
          <p:spPr>
            <a:xfrm rot="5400000">
              <a:off x="995318" y="3166550"/>
              <a:ext cx="600164" cy="573234"/>
            </a:xfrm>
            <a:prstGeom prst="rect">
              <a:avLst/>
            </a:prstGeom>
          </p:spPr>
          <p:txBody>
            <a:bodyPr vert="vert270" wrap="none" anchor="t" anchorCtr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Relative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MALAT1 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RN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60050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533401" y="4816405"/>
            <a:ext cx="5715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4.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Dose dependent knock-down of </a:t>
            </a:r>
            <a:r>
              <a:rPr lang="en-US" sz="1200" i="1" dirty="0">
                <a:solidFill>
                  <a:prstClr val="black"/>
                </a:solidFill>
                <a:latin typeface="Helvetica"/>
                <a:cs typeface="Helvetica"/>
              </a:rPr>
              <a:t>MALAT-1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 RNA by </a:t>
            </a:r>
            <a:r>
              <a:rPr lang="en-US" sz="1200" b="1" dirty="0">
                <a:solidFill>
                  <a:prstClr val="black"/>
                </a:solidFill>
                <a:latin typeface="Helvetica"/>
                <a:cs typeface="Helvetica"/>
              </a:rPr>
              <a:t>anti-MALAT1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 using </a:t>
            </a:r>
            <a:r>
              <a:rPr lang="en-US" sz="1200" dirty="0" err="1">
                <a:solidFill>
                  <a:prstClr val="black"/>
                </a:solidFill>
                <a:latin typeface="Helvetica"/>
                <a:cs typeface="Helvetica"/>
              </a:rPr>
              <a:t>lipofectamine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 RNAiMAX in </a:t>
            </a:r>
            <a:r>
              <a:rPr lang="en-US" altLang="zh-CN" sz="1200" dirty="0">
                <a:solidFill>
                  <a:prstClr val="black"/>
                </a:solidFill>
                <a:latin typeface="Helvetica"/>
                <a:cs typeface="Helvetica"/>
              </a:rPr>
              <a:t>FRDA patient derived fibroblasts GM03816 post 72h transfection (n=3)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.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ll data are presented as ±STDEV. </a:t>
            </a:r>
            <a:endParaRPr lang="en-US" sz="1200" dirty="0"/>
          </a:p>
        </p:txBody>
      </p:sp>
      <p:grpSp>
        <p:nvGrpSpPr>
          <p:cNvPr id="2" name="Group 1"/>
          <p:cNvGrpSpPr/>
          <p:nvPr/>
        </p:nvGrpSpPr>
        <p:grpSpPr>
          <a:xfrm>
            <a:off x="1062122" y="2362200"/>
            <a:ext cx="4675737" cy="2377440"/>
            <a:chOff x="1062122" y="2362200"/>
            <a:chExt cx="4675737" cy="2377440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09648741"/>
                </p:ext>
              </p:extLst>
            </p:nvPr>
          </p:nvGraphicFramePr>
          <p:xfrm>
            <a:off x="1348739" y="2362200"/>
            <a:ext cx="438912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4" name="Rectangle 13"/>
            <p:cNvSpPr/>
            <p:nvPr/>
          </p:nvSpPr>
          <p:spPr>
            <a:xfrm>
              <a:off x="2951584" y="2830292"/>
              <a:ext cx="1851789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IC</a:t>
              </a:r>
              <a:r>
                <a:rPr lang="en-US" sz="110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= 0.17 ± 0.03 </a:t>
              </a:r>
              <a:r>
                <a:rPr lang="en-US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nM</a:t>
              </a:r>
              <a:endParaRPr lang="en-US" sz="11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MALAT1 </a:t>
              </a:r>
              <a:r>
                <a:rPr lang="en-US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apmer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(</a:t>
              </a:r>
              <a:r>
                <a:rPr lang="en-US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nM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5" name="Rectangle 4"/>
            <p:cNvSpPr/>
            <p:nvPr/>
          </p:nvSpPr>
          <p:spPr>
            <a:xfrm rot="5400000">
              <a:off x="1048657" y="3147500"/>
              <a:ext cx="600164" cy="573234"/>
            </a:xfrm>
            <a:prstGeom prst="rect">
              <a:avLst/>
            </a:prstGeom>
          </p:spPr>
          <p:txBody>
            <a:bodyPr vert="vert270" wrap="none" anchor="t" anchorCtr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Relative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MALAT1 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RN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44391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609600" y="7114401"/>
            <a:ext cx="541020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5.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Additional replicates of Western Blot data </a:t>
            </a:r>
            <a:r>
              <a:rPr lang="en-US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in FRDA patient-derived NPCs F4259 and wild-type NPCs C7522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in </a:t>
            </a:r>
            <a:r>
              <a:rPr lang="en-US" sz="1200" b="1" dirty="0">
                <a:solidFill>
                  <a:prstClr val="black"/>
                </a:solidFill>
                <a:latin typeface="Helvetica"/>
                <a:cs typeface="Helvetica"/>
              </a:rPr>
              <a:t>Figure 7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.</a:t>
            </a:r>
            <a:endParaRPr lang="en-US" sz="1200" dirty="0"/>
          </a:p>
        </p:txBody>
      </p:sp>
      <p:sp>
        <p:nvSpPr>
          <p:cNvPr id="5" name="Rectangle 4"/>
          <p:cNvSpPr/>
          <p:nvPr/>
        </p:nvSpPr>
        <p:spPr>
          <a:xfrm>
            <a:off x="1033359" y="4114800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kern="0" dirty="0">
                <a:solidFill>
                  <a:srgbClr val="000000"/>
                </a:solidFill>
                <a:latin typeface="Arial"/>
                <a:ea typeface="SimSun" pitchFamily="2" charset="-122"/>
                <a:cs typeface="Arial"/>
              </a:rPr>
              <a:t>B.</a:t>
            </a:r>
            <a:endParaRPr lang="en-US" sz="1200" b="1" dirty="0"/>
          </a:p>
        </p:txBody>
      </p:sp>
      <p:sp>
        <p:nvSpPr>
          <p:cNvPr id="7" name="Rectangle 6"/>
          <p:cNvSpPr/>
          <p:nvPr/>
        </p:nvSpPr>
        <p:spPr>
          <a:xfrm>
            <a:off x="1005650" y="789801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kern="0" dirty="0">
                <a:solidFill>
                  <a:srgbClr val="000000"/>
                </a:solidFill>
                <a:latin typeface="Arial"/>
                <a:ea typeface="SimSun" pitchFamily="2" charset="-122"/>
                <a:cs typeface="Arial"/>
              </a:rPr>
              <a:t>A.</a:t>
            </a:r>
            <a:endParaRPr lang="en-US" sz="12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1829113" y="457200"/>
            <a:ext cx="3127248" cy="1646318"/>
            <a:chOff x="1868694" y="77526"/>
            <a:chExt cx="5772173" cy="3079809"/>
          </a:xfrm>
        </p:grpSpPr>
        <p:sp>
          <p:nvSpPr>
            <p:cNvPr id="9" name="TextBox 8"/>
            <p:cNvSpPr txBox="1"/>
            <p:nvPr/>
          </p:nvSpPr>
          <p:spPr>
            <a:xfrm>
              <a:off x="1868694" y="1931378"/>
              <a:ext cx="1197335" cy="485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5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76427" y="2611508"/>
              <a:ext cx="1197335" cy="485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50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2983298" y="2176947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2991788" y="2833679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876425" y="1038376"/>
              <a:ext cx="1189603" cy="485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et 2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271508" y="2045849"/>
              <a:ext cx="847125" cy="485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XN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29985" y="2672319"/>
              <a:ext cx="1410882" cy="485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β</a:t>
              </a:r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-Tubulin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8349766">
              <a:off x="4824789" y="871028"/>
              <a:ext cx="1856843" cy="51127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-90%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8349766">
              <a:off x="3744214" y="820632"/>
              <a:ext cx="1985792" cy="51127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4259-100%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8349766">
              <a:off x="3255140" y="885254"/>
              <a:ext cx="1826855" cy="51127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4259-90%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8349766">
              <a:off x="4285615" y="871026"/>
              <a:ext cx="1856843" cy="51127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-60%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8349766">
              <a:off x="5321359" y="829778"/>
              <a:ext cx="2015780" cy="51127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-100%</a:t>
              </a: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501585" y="1949473"/>
              <a:ext cx="2743200" cy="590107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86785" y="2672320"/>
              <a:ext cx="2743200" cy="412273"/>
            </a:xfrm>
            <a:prstGeom prst="rect">
              <a:avLst/>
            </a:prstGeom>
          </p:spPr>
        </p:pic>
      </p:grpSp>
      <p:grpSp>
        <p:nvGrpSpPr>
          <p:cNvPr id="25" name="Group 24"/>
          <p:cNvGrpSpPr/>
          <p:nvPr/>
        </p:nvGrpSpPr>
        <p:grpSpPr>
          <a:xfrm>
            <a:off x="1842200" y="2092113"/>
            <a:ext cx="3250424" cy="1659107"/>
            <a:chOff x="2061200" y="2767818"/>
            <a:chExt cx="5833132" cy="2913314"/>
          </a:xfrm>
        </p:grpSpPr>
        <p:sp>
          <p:nvSpPr>
            <p:cNvPr id="26" name="TextBox 25"/>
            <p:cNvSpPr txBox="1"/>
            <p:nvPr/>
          </p:nvSpPr>
          <p:spPr>
            <a:xfrm>
              <a:off x="6422491" y="5194735"/>
              <a:ext cx="1471841" cy="486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β</a:t>
              </a:r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-Tubulin</a:t>
              </a: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2061200" y="2767818"/>
              <a:ext cx="5286540" cy="2852500"/>
              <a:chOff x="2061200" y="2767818"/>
              <a:chExt cx="5286540" cy="2852500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74564" y="5194735"/>
                <a:ext cx="2743200" cy="419343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2061200" y="4453795"/>
                <a:ext cx="1249068" cy="486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 </a:t>
                </a:r>
                <a:r>
                  <a:rPr lang="en-US" sz="12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n-US" sz="12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068933" y="5133921"/>
                <a:ext cx="1249068" cy="486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50 </a:t>
                </a:r>
                <a:r>
                  <a:rPr lang="en-US" sz="12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n-US" sz="12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31" name="Straight Connector 30"/>
              <p:cNvCxnSpPr/>
              <p:nvPr/>
            </p:nvCxnSpPr>
            <p:spPr>
              <a:xfrm>
                <a:off x="3175804" y="4699362"/>
                <a:ext cx="28554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3184294" y="5356094"/>
                <a:ext cx="28554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2068933" y="3560793"/>
                <a:ext cx="1106871" cy="4863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Set 3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464014" y="4568265"/>
                <a:ext cx="883726" cy="486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XN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8349766">
                <a:off x="4909752" y="3506791"/>
                <a:ext cx="1742922" cy="4970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flatTx/>
              </a:bodyPr>
              <a:lstStyle/>
              <a:p>
                <a:r>
                  <a:rPr lang="en-US" altLang="zh-CN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7522-90%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8349766">
                <a:off x="3844969" y="3458582"/>
                <a:ext cx="1863960" cy="4970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flatTx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4259-100%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8349766">
                <a:off x="3381072" y="3506793"/>
                <a:ext cx="1714774" cy="4970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flatTx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4259-90%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8349766">
                <a:off x="4344263" y="3503516"/>
                <a:ext cx="1742922" cy="4970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flatTx/>
              </a:bodyPr>
              <a:lstStyle/>
              <a:p>
                <a:r>
                  <a:rPr lang="en-US" altLang="zh-CN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7522-60%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8349766">
                <a:off x="5420255" y="3465324"/>
                <a:ext cx="1892108" cy="4970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flatTx/>
              </a:bodyPr>
              <a:lstStyle/>
              <a:p>
                <a:r>
                  <a:rPr lang="en-US" altLang="zh-CN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7522-100%</a:t>
                </a:r>
              </a:p>
            </p:txBody>
          </p:sp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574564" y="4517408"/>
                <a:ext cx="2743200" cy="539126"/>
              </a:xfrm>
              <a:prstGeom prst="rect">
                <a:avLst/>
              </a:prstGeom>
            </p:spPr>
          </p:pic>
        </p:grpSp>
      </p:grpSp>
      <p:grpSp>
        <p:nvGrpSpPr>
          <p:cNvPr id="41" name="Group 40"/>
          <p:cNvGrpSpPr/>
          <p:nvPr/>
        </p:nvGrpSpPr>
        <p:grpSpPr>
          <a:xfrm>
            <a:off x="1752913" y="3826247"/>
            <a:ext cx="3289687" cy="1509243"/>
            <a:chOff x="2761039" y="1049510"/>
            <a:chExt cx="6436524" cy="3008489"/>
          </a:xfrm>
        </p:grpSpPr>
        <p:sp>
          <p:nvSpPr>
            <p:cNvPr id="42" name="TextBox 41"/>
            <p:cNvSpPr txBox="1"/>
            <p:nvPr/>
          </p:nvSpPr>
          <p:spPr>
            <a:xfrm>
              <a:off x="2761039" y="2836382"/>
              <a:ext cx="1300556" cy="51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5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768771" y="3516506"/>
              <a:ext cx="1300556" cy="51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50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4050340" y="3081949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4058830" y="3738681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2943464" y="1943377"/>
              <a:ext cx="1207491" cy="552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et 2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7706574" y="2920336"/>
              <a:ext cx="920154" cy="51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XN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665051" y="3546806"/>
              <a:ext cx="1532512" cy="5111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β</a:t>
              </a:r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-Tubulin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 rot="18349766">
              <a:off x="5871208" y="2112206"/>
              <a:ext cx="1175034" cy="517587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BNA-2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 rot="18349766">
              <a:off x="4772680" y="1950721"/>
              <a:ext cx="1528036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trl-ASO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 rot="18349766">
              <a:off x="4181632" y="1785889"/>
              <a:ext cx="1946629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4259-90%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 rot="18349766">
              <a:off x="5198681" y="1814306"/>
              <a:ext cx="1914676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s-siRNA-1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 rot="18349766">
              <a:off x="6776264" y="1767817"/>
              <a:ext cx="1978584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-90%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 rot="18349766">
              <a:off x="6391487" y="1987694"/>
              <a:ext cx="1441279" cy="517587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iExon-2</a:t>
              </a:r>
            </a:p>
          </p:txBody>
        </p:sp>
        <p:pic>
          <p:nvPicPr>
            <p:cNvPr id="55" name="Picture 54"/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464652" y="3516508"/>
              <a:ext cx="3200400" cy="478411"/>
            </a:xfrm>
            <a:prstGeom prst="rect">
              <a:avLst/>
            </a:prstGeom>
          </p:spPr>
        </p:pic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464652" y="2932652"/>
              <a:ext cx="3200400" cy="384748"/>
            </a:xfrm>
            <a:prstGeom prst="rect">
              <a:avLst/>
            </a:prstGeom>
          </p:spPr>
        </p:pic>
      </p:grpSp>
      <p:grpSp>
        <p:nvGrpSpPr>
          <p:cNvPr id="57" name="Group 56"/>
          <p:cNvGrpSpPr/>
          <p:nvPr/>
        </p:nvGrpSpPr>
        <p:grpSpPr>
          <a:xfrm>
            <a:off x="1752913" y="5429726"/>
            <a:ext cx="3259462" cy="1504474"/>
            <a:chOff x="2820177" y="1028986"/>
            <a:chExt cx="6377386" cy="3045768"/>
          </a:xfrm>
        </p:grpSpPr>
        <p:sp>
          <p:nvSpPr>
            <p:cNvPr id="58" name="TextBox 57"/>
            <p:cNvSpPr txBox="1"/>
            <p:nvPr/>
          </p:nvSpPr>
          <p:spPr>
            <a:xfrm>
              <a:off x="2820177" y="2836379"/>
              <a:ext cx="1300556" cy="5279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5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827909" y="3516509"/>
              <a:ext cx="1300556" cy="5279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50 </a:t>
              </a:r>
              <a:r>
                <a:rPr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60" name="Straight Connector 59"/>
            <p:cNvCxnSpPr/>
            <p:nvPr/>
          </p:nvCxnSpPr>
          <p:spPr>
            <a:xfrm>
              <a:off x="4050340" y="3081949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4058830" y="3738681"/>
              <a:ext cx="2855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2943466" y="1943377"/>
              <a:ext cx="1106872" cy="560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et 3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706574" y="2920333"/>
              <a:ext cx="920154" cy="5279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XN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665051" y="3546804"/>
              <a:ext cx="1532512" cy="5279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β</a:t>
              </a:r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-Tubulin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18349766">
              <a:off x="5768254" y="1997349"/>
              <a:ext cx="1213551" cy="51758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BNA-2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 rot="18349766">
              <a:off x="4735824" y="1908461"/>
              <a:ext cx="1551875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trl-ASO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rot="18349766">
              <a:off x="4165452" y="1746500"/>
              <a:ext cx="1976998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4259-90%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 rot="18349766">
              <a:off x="5125027" y="1749927"/>
              <a:ext cx="1944546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s-siRNA-1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rot="18349766">
              <a:off x="6745141" y="1804991"/>
              <a:ext cx="2009450" cy="541970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C7522-90%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rot="18349766">
              <a:off x="6200903" y="1931549"/>
              <a:ext cx="1488525" cy="517586"/>
            </a:xfrm>
            <a:prstGeom prst="rect">
              <a:avLst/>
            </a:prstGeom>
            <a:noFill/>
          </p:spPr>
          <p:txBody>
            <a:bodyPr wrap="none" rtlCol="0">
              <a:spAutoFit/>
              <a:flatTx/>
            </a:bodyPr>
            <a:lstStyle/>
            <a:p>
              <a:r>
                <a:rPr lang="en-US" altLang="zh-CN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siExon-2</a:t>
              </a:r>
            </a:p>
          </p:txBody>
        </p:sp>
        <p:pic>
          <p:nvPicPr>
            <p:cNvPr id="71" name="Picture 70"/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459485" y="3501965"/>
              <a:ext cx="3200400" cy="571500"/>
            </a:xfrm>
            <a:prstGeom prst="rect">
              <a:avLst/>
            </a:prstGeom>
          </p:spPr>
        </p:pic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459485" y="2967350"/>
              <a:ext cx="3200400" cy="38338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664791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6028492"/>
            <a:ext cx="541020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6.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Electroporation alone did not alter FXN mRNA expression in FRDA patient derived NPCs F4259 post 72h culture (n=4). All data are presented as ±STDEV. EP(-) is non-oligo treatment, no electroporation control. 0-EP is non-oligo treatment and electroporation using optimization 4 (same condition as the activating </a:t>
            </a:r>
            <a:r>
              <a:rPr lang="en-US" sz="1200" dirty="0" err="1">
                <a:solidFill>
                  <a:prstClr val="black"/>
                </a:solidFill>
                <a:latin typeface="Helvetica"/>
                <a:cs typeface="Helvetica"/>
              </a:rPr>
              <a:t>oligos</a:t>
            </a:r>
            <a:r>
              <a:rPr lang="en-US" sz="1200" dirty="0">
                <a:solidFill>
                  <a:prstClr val="black"/>
                </a:solidFill>
                <a:latin typeface="Helvetica"/>
                <a:cs typeface="Helvetica"/>
              </a:rPr>
              <a:t>) control.</a:t>
            </a:r>
            <a:endParaRPr lang="en-US" sz="1200" dirty="0"/>
          </a:p>
        </p:txBody>
      </p:sp>
      <p:grpSp>
        <p:nvGrpSpPr>
          <p:cNvPr id="5" name="Group 4"/>
          <p:cNvGrpSpPr/>
          <p:nvPr/>
        </p:nvGrpSpPr>
        <p:grpSpPr>
          <a:xfrm>
            <a:off x="775823" y="2438400"/>
            <a:ext cx="5077754" cy="3200400"/>
            <a:chOff x="568666" y="3505200"/>
            <a:chExt cx="5077754" cy="32004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3754498"/>
                </p:ext>
              </p:extLst>
            </p:nvPr>
          </p:nvGraphicFramePr>
          <p:xfrm>
            <a:off x="982980" y="3505200"/>
            <a:ext cx="4663440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Rectangle 3"/>
            <p:cNvSpPr/>
            <p:nvPr/>
          </p:nvSpPr>
          <p:spPr>
            <a:xfrm rot="5400000">
              <a:off x="445555" y="4618168"/>
              <a:ext cx="800219" cy="553998"/>
            </a:xfrm>
            <a:prstGeom prst="rect">
              <a:avLst/>
            </a:prstGeom>
          </p:spPr>
          <p:txBody>
            <a:bodyPr vert="vert270" wrap="none" anchor="t" anchorCtr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Relative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FXN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mRNA </a:t>
              </a:r>
            </a:p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leve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05716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71</TotalTime>
  <Words>412</Words>
  <Application>Microsoft Office PowerPoint</Application>
  <PresentationFormat>Letter Paper (8.5x11 in)</PresentationFormat>
  <Paragraphs>79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宋体</vt:lpstr>
      <vt:lpstr>宋体</vt:lpstr>
      <vt:lpstr>Arial</vt:lpstr>
      <vt:lpstr>Calibri</vt:lpstr>
      <vt:lpstr>Helvetica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ulong Shen</dc:creator>
  <cp:lastModifiedBy>Xiulong Shen</cp:lastModifiedBy>
  <cp:revision>286</cp:revision>
  <cp:lastPrinted>2019-03-20T14:47:55Z</cp:lastPrinted>
  <dcterms:created xsi:type="dcterms:W3CDTF">2014-08-25T16:31:19Z</dcterms:created>
  <dcterms:modified xsi:type="dcterms:W3CDTF">2019-05-21T20:40:22Z</dcterms:modified>
</cp:coreProperties>
</file>